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wmf" ContentType="image/x-wmf"/>
  <Override PartName="/ppt/media/image3.wmf" ContentType="image/x-wmf"/>
  <Override PartName="/ppt/media/image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</p:sldIdLst>
  <p:sldSz cx="32918400" cy="219456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958284-FE8E-40EA-AA5F-E1BB2064302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646280" y="879480"/>
            <a:ext cx="29625840" cy="365760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ctr">
            <a:noAutofit/>
          </a:bodyPr>
          <a:p>
            <a:pPr indent="0" algn="ctr">
              <a:buNone/>
              <a:tabLst>
                <a:tab algn="l" pos="0"/>
                <a:tab algn="l" pos="3133800"/>
                <a:tab algn="l" pos="6267600"/>
                <a:tab algn="l" pos="940104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646280" y="5121360"/>
            <a:ext cx="29625840" cy="690804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t">
            <a:normAutofit/>
          </a:bodyPr>
          <a:p>
            <a:pPr indent="0">
              <a:spcBef>
                <a:spcPts val="2750"/>
              </a:spcBef>
              <a:buNone/>
              <a:tabLst>
                <a:tab algn="l" pos="3133800"/>
                <a:tab algn="l" pos="6267600"/>
                <a:tab algn="l" pos="9401040"/>
              </a:tabLst>
            </a:pPr>
            <a:endParaRPr b="0" lang="en-US" sz="1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1646280" y="12686040"/>
            <a:ext cx="29625840" cy="690804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t">
            <a:normAutofit/>
          </a:bodyPr>
          <a:p>
            <a:pPr indent="0">
              <a:spcBef>
                <a:spcPts val="2750"/>
              </a:spcBef>
              <a:buNone/>
              <a:tabLst>
                <a:tab algn="l" pos="3133800"/>
                <a:tab algn="l" pos="6267600"/>
                <a:tab algn="l" pos="9401040"/>
              </a:tabLst>
            </a:pPr>
            <a:endParaRPr b="0" lang="en-US" sz="1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07C61D-0A9E-4168-BF75-6ADD994F177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646280" y="879480"/>
            <a:ext cx="29625840" cy="365760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ctr">
            <a:noAutofit/>
          </a:bodyPr>
          <a:p>
            <a:pPr indent="0" algn="ctr">
              <a:buNone/>
              <a:tabLst>
                <a:tab algn="l" pos="0"/>
                <a:tab algn="l" pos="3133800"/>
                <a:tab algn="l" pos="6267600"/>
                <a:tab algn="l" pos="940104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646280" y="5121360"/>
            <a:ext cx="14457240" cy="690804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t">
            <a:normAutofit/>
          </a:bodyPr>
          <a:p>
            <a:pPr indent="0">
              <a:spcBef>
                <a:spcPts val="2750"/>
              </a:spcBef>
              <a:buNone/>
              <a:tabLst>
                <a:tab algn="l" pos="3133800"/>
                <a:tab algn="l" pos="6267600"/>
                <a:tab algn="l" pos="9401040"/>
              </a:tabLst>
            </a:pPr>
            <a:endParaRPr b="0" lang="en-US" sz="1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16826760" y="5121360"/>
            <a:ext cx="14457240" cy="690804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t">
            <a:normAutofit/>
          </a:bodyPr>
          <a:p>
            <a:pPr indent="0">
              <a:spcBef>
                <a:spcPts val="2750"/>
              </a:spcBef>
              <a:buNone/>
              <a:tabLst>
                <a:tab algn="l" pos="3133800"/>
                <a:tab algn="l" pos="6267600"/>
                <a:tab algn="l" pos="9401040"/>
              </a:tabLst>
            </a:pPr>
            <a:endParaRPr b="0" lang="en-US" sz="1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646280" y="12686040"/>
            <a:ext cx="14457240" cy="690804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t">
            <a:normAutofit/>
          </a:bodyPr>
          <a:p>
            <a:pPr indent="0">
              <a:spcBef>
                <a:spcPts val="2750"/>
              </a:spcBef>
              <a:buNone/>
              <a:tabLst>
                <a:tab algn="l" pos="3133800"/>
                <a:tab algn="l" pos="6267600"/>
                <a:tab algn="l" pos="9401040"/>
              </a:tabLst>
            </a:pPr>
            <a:endParaRPr b="0" lang="en-US" sz="1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16826760" y="12686040"/>
            <a:ext cx="14457240" cy="690804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t">
            <a:normAutofit/>
          </a:bodyPr>
          <a:p>
            <a:pPr indent="0">
              <a:spcBef>
                <a:spcPts val="2750"/>
              </a:spcBef>
              <a:buNone/>
              <a:tabLst>
                <a:tab algn="l" pos="3133800"/>
                <a:tab algn="l" pos="6267600"/>
                <a:tab algn="l" pos="9401040"/>
              </a:tabLst>
            </a:pPr>
            <a:endParaRPr b="0" lang="en-US" sz="1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619307-58CC-4179-8555-FA4A36F95D7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646280" y="879480"/>
            <a:ext cx="29625840" cy="365760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ctr">
            <a:noAutofit/>
          </a:bodyPr>
          <a:p>
            <a:pPr indent="0" algn="ctr">
              <a:buNone/>
              <a:tabLst>
                <a:tab algn="l" pos="0"/>
                <a:tab algn="l" pos="3133800"/>
                <a:tab algn="l" pos="6267600"/>
                <a:tab algn="l" pos="940104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646280" y="5121360"/>
            <a:ext cx="9539280" cy="690804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t">
            <a:normAutofit/>
          </a:bodyPr>
          <a:p>
            <a:pPr indent="0">
              <a:spcBef>
                <a:spcPts val="2750"/>
              </a:spcBef>
              <a:buNone/>
              <a:tabLst>
                <a:tab algn="l" pos="3133800"/>
                <a:tab algn="l" pos="6267600"/>
                <a:tab algn="l" pos="9401040"/>
              </a:tabLst>
            </a:pPr>
            <a:endParaRPr b="0" lang="en-US" sz="1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1662920" y="5121360"/>
            <a:ext cx="9539280" cy="690804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t">
            <a:normAutofit/>
          </a:bodyPr>
          <a:p>
            <a:pPr indent="0">
              <a:spcBef>
                <a:spcPts val="2750"/>
              </a:spcBef>
              <a:buNone/>
              <a:tabLst>
                <a:tab algn="l" pos="3133800"/>
                <a:tab algn="l" pos="6267600"/>
                <a:tab algn="l" pos="9401040"/>
              </a:tabLst>
            </a:pPr>
            <a:endParaRPr b="0" lang="en-US" sz="1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21679560" y="5121360"/>
            <a:ext cx="9539280" cy="690804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t">
            <a:normAutofit/>
          </a:bodyPr>
          <a:p>
            <a:pPr indent="0">
              <a:spcBef>
                <a:spcPts val="2750"/>
              </a:spcBef>
              <a:buNone/>
              <a:tabLst>
                <a:tab algn="l" pos="3133800"/>
                <a:tab algn="l" pos="6267600"/>
                <a:tab algn="l" pos="9401040"/>
              </a:tabLst>
            </a:pPr>
            <a:endParaRPr b="0" lang="en-US" sz="1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1646280" y="12686040"/>
            <a:ext cx="9539280" cy="690804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t">
            <a:normAutofit/>
          </a:bodyPr>
          <a:p>
            <a:pPr indent="0">
              <a:spcBef>
                <a:spcPts val="2750"/>
              </a:spcBef>
              <a:buNone/>
              <a:tabLst>
                <a:tab algn="l" pos="3133800"/>
                <a:tab algn="l" pos="6267600"/>
                <a:tab algn="l" pos="9401040"/>
              </a:tabLst>
            </a:pPr>
            <a:endParaRPr b="0" lang="en-US" sz="1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1662920" y="12686040"/>
            <a:ext cx="9539280" cy="690804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t">
            <a:normAutofit/>
          </a:bodyPr>
          <a:p>
            <a:pPr indent="0">
              <a:spcBef>
                <a:spcPts val="2750"/>
              </a:spcBef>
              <a:buNone/>
              <a:tabLst>
                <a:tab algn="l" pos="3133800"/>
                <a:tab algn="l" pos="6267600"/>
                <a:tab algn="l" pos="9401040"/>
              </a:tabLst>
            </a:pPr>
            <a:endParaRPr b="0" lang="en-US" sz="1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21679560" y="12686040"/>
            <a:ext cx="9539280" cy="690804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t">
            <a:normAutofit/>
          </a:bodyPr>
          <a:p>
            <a:pPr indent="0">
              <a:spcBef>
                <a:spcPts val="2750"/>
              </a:spcBef>
              <a:buNone/>
              <a:tabLst>
                <a:tab algn="l" pos="3133800"/>
                <a:tab algn="l" pos="6267600"/>
                <a:tab algn="l" pos="9401040"/>
              </a:tabLst>
            </a:pPr>
            <a:endParaRPr b="0" lang="en-US" sz="1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822A89-64D7-424F-93E9-B2EDFB745CD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646280" y="879480"/>
            <a:ext cx="29625840" cy="365760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ctr">
            <a:noAutofit/>
          </a:bodyPr>
          <a:p>
            <a:pPr indent="0" algn="ctr">
              <a:buNone/>
              <a:tabLst>
                <a:tab algn="l" pos="0"/>
                <a:tab algn="l" pos="3133800"/>
                <a:tab algn="l" pos="6267600"/>
                <a:tab algn="l" pos="940104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1646280" y="5121360"/>
            <a:ext cx="29625840" cy="14482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750"/>
              </a:spcBef>
              <a:buNone/>
              <a:tabLst>
                <a:tab algn="l" pos="0"/>
                <a:tab algn="l" pos="3133800"/>
                <a:tab algn="l" pos="6267600"/>
                <a:tab algn="l" pos="9401040"/>
              </a:tabLst>
            </a:pPr>
            <a:endParaRPr b="0" lang="en-US" sz="1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E8F9BB-CCE7-4B14-9DAF-A2E86DE52F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646280" y="879480"/>
            <a:ext cx="29625840" cy="365760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ctr">
            <a:noAutofit/>
          </a:bodyPr>
          <a:p>
            <a:pPr indent="0" algn="ctr">
              <a:buNone/>
              <a:tabLst>
                <a:tab algn="l" pos="0"/>
                <a:tab algn="l" pos="3133800"/>
                <a:tab algn="l" pos="6267600"/>
                <a:tab algn="l" pos="940104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1646280" y="5121360"/>
            <a:ext cx="29625840" cy="1448280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t">
            <a:normAutofit/>
          </a:bodyPr>
          <a:p>
            <a:pPr indent="0">
              <a:spcBef>
                <a:spcPts val="2750"/>
              </a:spcBef>
              <a:buNone/>
              <a:tabLst>
                <a:tab algn="l" pos="3133800"/>
                <a:tab algn="l" pos="6267600"/>
                <a:tab algn="l" pos="9401040"/>
              </a:tabLst>
            </a:pPr>
            <a:endParaRPr b="0" lang="en-US" sz="1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DC9F38-1E3D-41EF-B650-C17DAD2F1C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646280" y="879480"/>
            <a:ext cx="29625840" cy="365760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ctr">
            <a:noAutofit/>
          </a:bodyPr>
          <a:p>
            <a:pPr indent="0" algn="ctr">
              <a:buNone/>
              <a:tabLst>
                <a:tab algn="l" pos="0"/>
                <a:tab algn="l" pos="3133800"/>
                <a:tab algn="l" pos="6267600"/>
                <a:tab algn="l" pos="940104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1646280" y="5121360"/>
            <a:ext cx="14457240" cy="1448280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t">
            <a:normAutofit/>
          </a:bodyPr>
          <a:p>
            <a:pPr indent="0">
              <a:spcBef>
                <a:spcPts val="2750"/>
              </a:spcBef>
              <a:buNone/>
              <a:tabLst>
                <a:tab algn="l" pos="3133800"/>
                <a:tab algn="l" pos="6267600"/>
                <a:tab algn="l" pos="9401040"/>
              </a:tabLst>
            </a:pPr>
            <a:endParaRPr b="0" lang="en-US" sz="1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16826760" y="5121360"/>
            <a:ext cx="14457240" cy="1448280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t">
            <a:normAutofit/>
          </a:bodyPr>
          <a:p>
            <a:pPr indent="0">
              <a:spcBef>
                <a:spcPts val="2750"/>
              </a:spcBef>
              <a:buNone/>
              <a:tabLst>
                <a:tab algn="l" pos="3133800"/>
                <a:tab algn="l" pos="6267600"/>
                <a:tab algn="l" pos="9401040"/>
              </a:tabLst>
            </a:pPr>
            <a:endParaRPr b="0" lang="en-US" sz="1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8E70A5-78D4-4A5B-AAE9-8B32110E32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646280" y="879480"/>
            <a:ext cx="29625840" cy="365760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ctr">
            <a:noAutofit/>
          </a:bodyPr>
          <a:p>
            <a:pPr indent="0" algn="ctr">
              <a:buNone/>
              <a:tabLst>
                <a:tab algn="l" pos="0"/>
                <a:tab algn="l" pos="3133800"/>
                <a:tab algn="l" pos="6267600"/>
                <a:tab algn="l" pos="940104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F37890-A60D-49AB-BC8B-8E5D28FEBF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646280" y="879480"/>
            <a:ext cx="29625840" cy="169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750"/>
              </a:spcBef>
              <a:tabLst>
                <a:tab algn="l" pos="0"/>
                <a:tab algn="l" pos="3133800"/>
                <a:tab algn="l" pos="6267600"/>
                <a:tab algn="l" pos="9401040"/>
              </a:tabLst>
            </a:pPr>
            <a:endParaRPr b="0" lang="en-US" sz="1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41B5E9-1DEF-47DC-A7D8-AF34CC66505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646280" y="879480"/>
            <a:ext cx="29625840" cy="365760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ctr">
            <a:noAutofit/>
          </a:bodyPr>
          <a:p>
            <a:pPr indent="0" algn="ctr">
              <a:buNone/>
              <a:tabLst>
                <a:tab algn="l" pos="0"/>
                <a:tab algn="l" pos="3133800"/>
                <a:tab algn="l" pos="6267600"/>
                <a:tab algn="l" pos="940104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646280" y="5121360"/>
            <a:ext cx="14457240" cy="690804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t">
            <a:normAutofit/>
          </a:bodyPr>
          <a:p>
            <a:pPr indent="0">
              <a:spcBef>
                <a:spcPts val="2750"/>
              </a:spcBef>
              <a:buNone/>
              <a:tabLst>
                <a:tab algn="l" pos="3133800"/>
                <a:tab algn="l" pos="6267600"/>
                <a:tab algn="l" pos="9401040"/>
              </a:tabLst>
            </a:pPr>
            <a:endParaRPr b="0" lang="en-US" sz="1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16826760" y="5121360"/>
            <a:ext cx="14457240" cy="1448280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t">
            <a:normAutofit/>
          </a:bodyPr>
          <a:p>
            <a:pPr indent="0">
              <a:spcBef>
                <a:spcPts val="2750"/>
              </a:spcBef>
              <a:buNone/>
              <a:tabLst>
                <a:tab algn="l" pos="3133800"/>
                <a:tab algn="l" pos="6267600"/>
                <a:tab algn="l" pos="9401040"/>
              </a:tabLst>
            </a:pPr>
            <a:endParaRPr b="0" lang="en-US" sz="1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1646280" y="12686040"/>
            <a:ext cx="14457240" cy="690804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t">
            <a:normAutofit/>
          </a:bodyPr>
          <a:p>
            <a:pPr indent="0">
              <a:spcBef>
                <a:spcPts val="2750"/>
              </a:spcBef>
              <a:buNone/>
              <a:tabLst>
                <a:tab algn="l" pos="3133800"/>
                <a:tab algn="l" pos="6267600"/>
                <a:tab algn="l" pos="9401040"/>
              </a:tabLst>
            </a:pPr>
            <a:endParaRPr b="0" lang="en-US" sz="1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E8E26C-8733-4727-80FA-CEF60CE83C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646280" y="879480"/>
            <a:ext cx="29625840" cy="365760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ctr">
            <a:noAutofit/>
          </a:bodyPr>
          <a:p>
            <a:pPr indent="0" algn="ctr">
              <a:buNone/>
              <a:tabLst>
                <a:tab algn="l" pos="0"/>
                <a:tab algn="l" pos="3133800"/>
                <a:tab algn="l" pos="6267600"/>
                <a:tab algn="l" pos="940104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1646280" y="5121360"/>
            <a:ext cx="14457240" cy="1448280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t">
            <a:normAutofit/>
          </a:bodyPr>
          <a:p>
            <a:pPr indent="0">
              <a:spcBef>
                <a:spcPts val="2750"/>
              </a:spcBef>
              <a:buNone/>
              <a:tabLst>
                <a:tab algn="l" pos="3133800"/>
                <a:tab algn="l" pos="6267600"/>
                <a:tab algn="l" pos="9401040"/>
              </a:tabLst>
            </a:pPr>
            <a:endParaRPr b="0" lang="en-US" sz="1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16826760" y="5121360"/>
            <a:ext cx="14457240" cy="690804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t">
            <a:normAutofit/>
          </a:bodyPr>
          <a:p>
            <a:pPr indent="0">
              <a:spcBef>
                <a:spcPts val="2750"/>
              </a:spcBef>
              <a:buNone/>
              <a:tabLst>
                <a:tab algn="l" pos="3133800"/>
                <a:tab algn="l" pos="6267600"/>
                <a:tab algn="l" pos="9401040"/>
              </a:tabLst>
            </a:pPr>
            <a:endParaRPr b="0" lang="en-US" sz="1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16826760" y="12686040"/>
            <a:ext cx="14457240" cy="690804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t">
            <a:normAutofit/>
          </a:bodyPr>
          <a:p>
            <a:pPr indent="0">
              <a:spcBef>
                <a:spcPts val="2750"/>
              </a:spcBef>
              <a:buNone/>
              <a:tabLst>
                <a:tab algn="l" pos="3133800"/>
                <a:tab algn="l" pos="6267600"/>
                <a:tab algn="l" pos="9401040"/>
              </a:tabLst>
            </a:pPr>
            <a:endParaRPr b="0" lang="en-US" sz="1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F2B6D3-9AB9-4052-ACC0-31CA001C76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646280" y="879480"/>
            <a:ext cx="29625840" cy="365760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ctr">
            <a:noAutofit/>
          </a:bodyPr>
          <a:p>
            <a:pPr indent="0" algn="ctr">
              <a:buNone/>
              <a:tabLst>
                <a:tab algn="l" pos="0"/>
                <a:tab algn="l" pos="3133800"/>
                <a:tab algn="l" pos="6267600"/>
                <a:tab algn="l" pos="9401040"/>
              </a:tabLst>
            </a:pP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646280" y="5121360"/>
            <a:ext cx="14457240" cy="690804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t">
            <a:normAutofit/>
          </a:bodyPr>
          <a:p>
            <a:pPr indent="0">
              <a:spcBef>
                <a:spcPts val="2750"/>
              </a:spcBef>
              <a:buNone/>
              <a:tabLst>
                <a:tab algn="l" pos="3133800"/>
                <a:tab algn="l" pos="6267600"/>
                <a:tab algn="l" pos="9401040"/>
              </a:tabLst>
            </a:pPr>
            <a:endParaRPr b="0" lang="en-US" sz="1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16826760" y="5121360"/>
            <a:ext cx="14457240" cy="690804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t">
            <a:normAutofit/>
          </a:bodyPr>
          <a:p>
            <a:pPr indent="0">
              <a:spcBef>
                <a:spcPts val="2750"/>
              </a:spcBef>
              <a:buNone/>
              <a:tabLst>
                <a:tab algn="l" pos="3133800"/>
                <a:tab algn="l" pos="6267600"/>
                <a:tab algn="l" pos="9401040"/>
              </a:tabLst>
            </a:pPr>
            <a:endParaRPr b="0" lang="en-US" sz="1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1646280" y="12686040"/>
            <a:ext cx="29625840" cy="690804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t">
            <a:normAutofit/>
          </a:bodyPr>
          <a:p>
            <a:pPr indent="0">
              <a:spcBef>
                <a:spcPts val="2750"/>
              </a:spcBef>
              <a:buNone/>
              <a:tabLst>
                <a:tab algn="l" pos="3133800"/>
                <a:tab algn="l" pos="6267600"/>
                <a:tab algn="l" pos="9401040"/>
              </a:tabLst>
            </a:pPr>
            <a:endParaRPr b="0" lang="en-US" sz="1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BAD700-1829-415D-AD46-0E380A2233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646280" y="879480"/>
            <a:ext cx="29625840" cy="365760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ctr">
            <a:noAutofit/>
          </a:bodyPr>
          <a:p>
            <a:pPr indent="0" algn="ctr">
              <a:buNone/>
              <a:tabLst>
                <a:tab algn="l" pos="0"/>
                <a:tab algn="l" pos="3133800"/>
                <a:tab algn="l" pos="6267600"/>
                <a:tab algn="l" pos="9401040"/>
              </a:tabLst>
            </a:pPr>
            <a:r>
              <a:rPr b="0" lang="en-US" sz="151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1646280" y="5121360"/>
            <a:ext cx="29625840" cy="1448280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t">
            <a:normAutofit/>
          </a:bodyPr>
          <a:p>
            <a:pPr marL="1174680" indent="-1174680">
              <a:spcBef>
                <a:spcPts val="2750"/>
              </a:spcBef>
              <a:buClr>
                <a:srgbClr val="000000"/>
              </a:buClr>
              <a:buFont typeface="Arial"/>
              <a:buChar char="•"/>
              <a:tabLst>
                <a:tab algn="l" pos="3133800"/>
                <a:tab algn="l" pos="6267600"/>
                <a:tab algn="l" pos="9401040"/>
              </a:tabLst>
            </a:pPr>
            <a:r>
              <a:rPr b="0" lang="en-US" sz="110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11000" spc="-1" strike="noStrike">
              <a:solidFill>
                <a:srgbClr val="000000"/>
              </a:solidFill>
              <a:latin typeface="Calibri"/>
            </a:endParaRPr>
          </a:p>
          <a:p>
            <a:pPr lvl="1" marL="2546280" indent="-979560">
              <a:spcBef>
                <a:spcPts val="2750"/>
              </a:spcBef>
              <a:buClr>
                <a:srgbClr val="000000"/>
              </a:buClr>
              <a:buFont typeface="Arial"/>
              <a:buChar char="–"/>
              <a:tabLst>
                <a:tab algn="l" pos="3133800"/>
                <a:tab algn="l" pos="6267600"/>
                <a:tab algn="l" pos="9401040"/>
              </a:tabLst>
            </a:pPr>
            <a:r>
              <a:rPr b="0" lang="en-US" sz="110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11000" spc="-1" strike="noStrike">
              <a:solidFill>
                <a:srgbClr val="000000"/>
              </a:solidFill>
              <a:latin typeface="Calibri"/>
            </a:endParaRPr>
          </a:p>
          <a:p>
            <a:pPr lvl="2" marL="3917880" indent="-782640">
              <a:spcBef>
                <a:spcPts val="2750"/>
              </a:spcBef>
              <a:buClr>
                <a:srgbClr val="000000"/>
              </a:buClr>
              <a:buFont typeface="Arial"/>
              <a:buChar char="•"/>
              <a:tabLst>
                <a:tab algn="l" pos="3133800"/>
                <a:tab algn="l" pos="6267600"/>
                <a:tab algn="l" pos="9401040"/>
              </a:tabLst>
            </a:pPr>
            <a:r>
              <a:rPr b="0" lang="en-US" sz="110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11000" spc="-1" strike="noStrike">
              <a:solidFill>
                <a:srgbClr val="000000"/>
              </a:solidFill>
              <a:latin typeface="Calibri"/>
            </a:endParaRPr>
          </a:p>
          <a:p>
            <a:pPr lvl="3" marL="5484960" indent="-782640">
              <a:spcBef>
                <a:spcPts val="2750"/>
              </a:spcBef>
              <a:buClr>
                <a:srgbClr val="000000"/>
              </a:buClr>
              <a:buFont typeface="Arial"/>
              <a:buChar char="–"/>
              <a:tabLst>
                <a:tab algn="l" pos="3133800"/>
                <a:tab algn="l" pos="6267600"/>
                <a:tab algn="l" pos="9401040"/>
              </a:tabLst>
            </a:pPr>
            <a:r>
              <a:rPr b="0" lang="en-US" sz="110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11000" spc="-1" strike="noStrike">
              <a:solidFill>
                <a:srgbClr val="000000"/>
              </a:solidFill>
              <a:latin typeface="Calibri"/>
            </a:endParaRPr>
          </a:p>
          <a:p>
            <a:pPr lvl="4" marL="7053120" indent="-782640">
              <a:spcBef>
                <a:spcPts val="2750"/>
              </a:spcBef>
              <a:buClr>
                <a:srgbClr val="000000"/>
              </a:buClr>
              <a:buFont typeface="Arial"/>
              <a:buChar char="»"/>
              <a:tabLst>
                <a:tab algn="l" pos="3133800"/>
                <a:tab algn="l" pos="6267600"/>
                <a:tab algn="l" pos="9401040"/>
              </a:tabLst>
            </a:pPr>
            <a:r>
              <a:rPr b="0" lang="en-US" sz="110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11000" spc="-1" strike="noStrike">
              <a:solidFill>
                <a:srgbClr val="000000"/>
              </a:solidFill>
              <a:latin typeface="Calibri"/>
            </a:endParaRPr>
          </a:p>
          <a:p>
            <a:pPr lvl="5" marL="7053120" indent="-782640">
              <a:spcBef>
                <a:spcPts val="2750"/>
              </a:spcBef>
              <a:buClr>
                <a:srgbClr val="000000"/>
              </a:buClr>
              <a:buFont typeface="Arial"/>
              <a:buChar char="»"/>
              <a:tabLst>
                <a:tab algn="l" pos="3133800"/>
                <a:tab algn="l" pos="6267600"/>
                <a:tab algn="l" pos="9401040"/>
              </a:tabLst>
            </a:pPr>
            <a:r>
              <a:rPr b="0" lang="en-US" sz="110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11000" spc="-1" strike="noStrike">
              <a:solidFill>
                <a:srgbClr val="000000"/>
              </a:solidFill>
              <a:latin typeface="Calibri"/>
            </a:endParaRPr>
          </a:p>
          <a:p>
            <a:pPr lvl="6" marL="7053120" indent="-782640">
              <a:spcBef>
                <a:spcPts val="2750"/>
              </a:spcBef>
              <a:buClr>
                <a:srgbClr val="000000"/>
              </a:buClr>
              <a:buFont typeface="Arial"/>
              <a:buChar char="»"/>
              <a:tabLst>
                <a:tab algn="l" pos="3133800"/>
                <a:tab algn="l" pos="6267600"/>
                <a:tab algn="l" pos="9401040"/>
              </a:tabLst>
            </a:pPr>
            <a:r>
              <a:rPr b="0" lang="en-US" sz="110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1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1646280" y="20340360"/>
            <a:ext cx="7680240" cy="116820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ctr">
            <a:noAutofit/>
          </a:bodyPr>
          <a:lstStyle>
            <a:lvl1pPr indent="0">
              <a:buNone/>
              <a:tabLst>
                <a:tab algn="l" pos="0"/>
                <a:tab algn="l" pos="3133800"/>
                <a:tab algn="l" pos="6267600"/>
                <a:tab algn="l" pos="9401040"/>
              </a:tabLst>
              <a:defRPr b="0" lang="en-US" sz="41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3133800"/>
                <a:tab algn="l" pos="6267600"/>
                <a:tab algn="l" pos="9401040"/>
              </a:tabLst>
            </a:pPr>
            <a:r>
              <a:rPr b="0" lang="en-US" sz="41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4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1247480" y="20340360"/>
            <a:ext cx="10423440" cy="116820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ctr">
            <a:noAutofit/>
          </a:bodyPr>
          <a:p>
            <a:pPr indent="0">
              <a:buNone/>
              <a:tabLst>
                <a:tab algn="l" pos="0"/>
                <a:tab algn="l" pos="3133800"/>
                <a:tab algn="l" pos="6267600"/>
                <a:tab algn="l" pos="9401040"/>
              </a:tabLst>
            </a:pPr>
            <a:endParaRPr b="0" lang="en-US" sz="6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23591880" y="20340360"/>
            <a:ext cx="7680240" cy="1168200"/>
          </a:xfrm>
          <a:prstGeom prst="rect">
            <a:avLst/>
          </a:prstGeom>
          <a:noFill/>
          <a:ln w="0">
            <a:noFill/>
          </a:ln>
        </p:spPr>
        <p:txBody>
          <a:bodyPr lIns="313560" rIns="313560" tIns="156600" bIns="156600" anchor="ctr">
            <a:noAutofit/>
          </a:bodyPr>
          <a:lstStyle>
            <a:lvl1pPr indent="0" algn="r">
              <a:buNone/>
              <a:tabLst>
                <a:tab algn="l" pos="0"/>
                <a:tab algn="l" pos="3133800"/>
                <a:tab algn="l" pos="6267600"/>
                <a:tab algn="l" pos="9401040"/>
              </a:tabLst>
              <a:defRPr b="0" lang="en-US" sz="41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3133800"/>
                <a:tab algn="l" pos="6267600"/>
                <a:tab algn="l" pos="9401040"/>
              </a:tabLst>
            </a:pPr>
            <a:fld id="{542FE57D-B06C-4A2C-996B-CBDF717CBADA}" type="slidenum">
              <a:rPr b="0" lang="en-US" sz="41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4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image" Target="../media/image3.wmf"/><Relationship Id="rId3" Type="http://schemas.openxmlformats.org/officeDocument/2006/relationships/image" Target="../media/image4.png"/><Relationship Id="rId4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4"/>
          <p:cNvGrpSpPr/>
          <p:nvPr/>
        </p:nvGrpSpPr>
        <p:grpSpPr>
          <a:xfrm>
            <a:off x="1295280" y="5791320"/>
            <a:ext cx="30327840" cy="10362960"/>
            <a:chOff x="1295280" y="5791320"/>
            <a:chExt cx="30327840" cy="10362960"/>
          </a:xfrm>
        </p:grpSpPr>
        <p:sp>
          <p:nvSpPr>
            <p:cNvPr id="42" name="Rectangle 539"/>
            <p:cNvSpPr/>
            <p:nvPr/>
          </p:nvSpPr>
          <p:spPr>
            <a:xfrm>
              <a:off x="1295280" y="5791320"/>
              <a:ext cx="30327840" cy="6166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313560" rIns="313560" tIns="156600" bIns="156600" anchor="ctr">
              <a:noAutofit/>
            </a:bodyPr>
            <a:p>
              <a:pPr algn="ctr">
                <a:tabLst>
                  <a:tab algn="l" pos="0"/>
                  <a:tab algn="l" pos="3133800"/>
                  <a:tab algn="l" pos="6267600"/>
                  <a:tab algn="l" pos="9401040"/>
                </a:tabLst>
              </a:pPr>
              <a:r>
                <a:rPr b="1" lang="en-US" sz="9600" spc="-1" strike="noStrike">
                  <a:solidFill>
                    <a:srgbClr val="953735"/>
                  </a:solidFill>
                  <a:latin typeface="Calibri"/>
                </a:rPr>
                <a:t>Automated Vocabulary Maintenance System for the Open Access, Collaborative Consumer Health Vocabulary</a:t>
              </a:r>
              <a:endParaRPr b="0" lang="en-US" sz="9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Rectangle 540"/>
            <p:cNvSpPr/>
            <p:nvPr/>
          </p:nvSpPr>
          <p:spPr>
            <a:xfrm>
              <a:off x="4226040" y="12300480"/>
              <a:ext cx="21016800" cy="1734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90000"/>
                </a:lnSpc>
                <a:spcBef>
                  <a:spcPts val="1349"/>
                </a:spcBef>
                <a:tabLst>
                  <a:tab algn="l" pos="0"/>
                  <a:tab algn="l" pos="3133800"/>
                  <a:tab algn="l" pos="6267600"/>
                  <a:tab algn="l" pos="9401040"/>
                </a:tabLst>
              </a:pPr>
              <a:r>
                <a:rPr b="0" lang="en-US" sz="5400" spc="-1" strike="noStrike">
                  <a:solidFill>
                    <a:srgbClr val="1f497d"/>
                  </a:solidFill>
                  <a:latin typeface="Calibri"/>
                </a:rPr>
                <a:t>Kristina M Doing-Harris, BCompSci, MA, MS, PhD; Qing Zeng-Treitler, PhD</a:t>
              </a:r>
              <a:br>
                <a:rPr sz="5400"/>
              </a:br>
              <a:endParaRPr b="0" lang="en-US" sz="5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Text Box 546"/>
            <p:cNvSpPr/>
            <p:nvPr/>
          </p:nvSpPr>
          <p:spPr>
            <a:xfrm>
              <a:off x="2742840" y="13584960"/>
              <a:ext cx="26592480" cy="2569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360000" rIns="360000" tIns="360000" bIns="360000" anchor="ctr">
              <a:noAutofit/>
            </a:bodyPr>
            <a:p>
              <a:pPr lvl="1" marL="1566720">
                <a:lnSpc>
                  <a:spcPct val="100000"/>
                </a:lnSpc>
                <a:tabLst>
                  <a:tab algn="l" pos="0"/>
                  <a:tab algn="l" pos="3133800"/>
                  <a:tab algn="l" pos="6267600"/>
                  <a:tab algn="l" pos="9401040"/>
                </a:tabLst>
              </a:pPr>
              <a:r>
                <a:rPr b="0" i="1" lang="en-US" sz="4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Department of Biomedical Informatics, University of Utah, Salt Lake City, USA</a:t>
              </a:r>
              <a:endParaRPr b="0" lang="en-US" sz="4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Rectangle 16"/>
          <p:cNvSpPr/>
          <p:nvPr/>
        </p:nvSpPr>
        <p:spPr>
          <a:xfrm>
            <a:off x="4343400" y="3048120"/>
            <a:ext cx="23625000" cy="14082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1440" bIns="91440" anchor="t">
            <a:spAutoFit/>
          </a:bodyPr>
          <a:p>
            <a:pPr algn="ctr">
              <a:tabLst>
                <a:tab algn="l" pos="0"/>
                <a:tab algn="l" pos="3133800"/>
                <a:tab algn="l" pos="6267600"/>
                <a:tab algn="l" pos="9401040"/>
              </a:tabLst>
            </a:pPr>
            <a:r>
              <a:rPr b="1" lang="en-US" sz="7200" spc="-1" strike="noStrike">
                <a:solidFill>
                  <a:srgbClr val="000000"/>
                </a:solidFill>
                <a:latin typeface="Calibri"/>
              </a:rPr>
              <a:t>Introduction</a:t>
            </a: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3133800"/>
                <a:tab algn="l" pos="6267600"/>
                <a:tab algn="l" pos="9401040"/>
              </a:tabLst>
            </a:pPr>
            <a:r>
              <a:rPr b="0" i="1" lang="en-US" sz="6000" spc="-1" strike="noStrike">
                <a:solidFill>
                  <a:srgbClr val="000000"/>
                </a:solidFill>
                <a:latin typeface="Calibri"/>
              </a:rPr>
              <a:t> </a:t>
            </a:r>
            <a:endParaRPr b="0" lang="en-US" sz="60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3133800"/>
                <a:tab algn="l" pos="6267600"/>
                <a:tab algn="l" pos="9401040"/>
              </a:tabLst>
            </a:pPr>
            <a:r>
              <a:rPr b="0" lang="en-US" sz="6000" spc="-1" strike="noStrike">
                <a:solidFill>
                  <a:srgbClr val="000000"/>
                </a:solidFill>
                <a:latin typeface="Calibri"/>
              </a:rPr>
              <a:t>Controlled vocabularies play an important role in the development of biomedical informatics applications. </a:t>
            </a:r>
            <a:endParaRPr b="0" lang="en-US" sz="60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3133800"/>
                <a:tab algn="l" pos="6267600"/>
                <a:tab algn="l" pos="9401040"/>
              </a:tabLst>
            </a:pPr>
            <a:endParaRPr b="0" lang="en-US" sz="60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3133800"/>
                <a:tab algn="l" pos="6267600"/>
                <a:tab algn="l" pos="9401040"/>
              </a:tabLst>
            </a:pPr>
            <a:r>
              <a:rPr b="0" lang="en-US" sz="6000" spc="-1" strike="noStrike">
                <a:solidFill>
                  <a:srgbClr val="000000"/>
                </a:solidFill>
                <a:latin typeface="Calibri"/>
              </a:rPr>
              <a:t>Consumer health vocabulary (CHV), has been rising in prominence.</a:t>
            </a:r>
            <a:endParaRPr b="0" lang="en-US" sz="6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3133800"/>
                <a:tab algn="l" pos="6267600"/>
                <a:tab algn="l" pos="9401040"/>
              </a:tabLst>
            </a:pPr>
            <a:r>
              <a:rPr b="0" lang="en-US" sz="6000" spc="-1" strike="noStrike">
                <a:solidFill>
                  <a:srgbClr val="000000"/>
                </a:solidFill>
                <a:latin typeface="Calibri"/>
              </a:rPr>
              <a:t> </a:t>
            </a:r>
            <a:endParaRPr b="0" lang="en-US" sz="60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3133800"/>
                <a:tab algn="l" pos="6267600"/>
                <a:tab algn="l" pos="9401040"/>
              </a:tabLst>
            </a:pPr>
            <a:r>
              <a:rPr b="0" lang="en-US" sz="6000" spc="-1" strike="noStrike">
                <a:solidFill>
                  <a:srgbClr val="000000"/>
                </a:solidFill>
                <a:latin typeface="Calibri"/>
              </a:rPr>
              <a:t>Controlled vocabularies require maintenance and update, due to the continuing evolution of language itself.</a:t>
            </a:r>
            <a:endParaRPr b="0" lang="en-US" sz="60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3133800"/>
                <a:tab algn="l" pos="6267600"/>
                <a:tab algn="l" pos="9401040"/>
              </a:tabLst>
            </a:pPr>
            <a:endParaRPr b="0" lang="en-US" sz="60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3133800"/>
                <a:tab algn="l" pos="6267600"/>
                <a:tab algn="l" pos="9401040"/>
              </a:tabLst>
            </a:pPr>
            <a:r>
              <a:rPr b="0" lang="en-US" sz="6000" spc="-1" strike="noStrike">
                <a:solidFill>
                  <a:srgbClr val="000000"/>
                </a:solidFill>
                <a:latin typeface="Calibri"/>
              </a:rPr>
              <a:t>In healthcare especially there is a constant stream of new names (e.g. new medications, disorders, tests) being coined in the literature.</a:t>
            </a:r>
            <a:endParaRPr b="0" lang="en-US" sz="60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3133800"/>
                <a:tab algn="l" pos="6267600"/>
                <a:tab algn="l" pos="9401040"/>
              </a:tabLst>
            </a:pPr>
            <a:endParaRPr b="0" lang="en-US" sz="60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3133800"/>
                <a:tab algn="l" pos="6267600"/>
                <a:tab algn="l" pos="9401040"/>
              </a:tabLst>
            </a:pPr>
            <a:r>
              <a:rPr b="0" lang="en-US" sz="6000" spc="-1" strike="noStrike">
                <a:solidFill>
                  <a:srgbClr val="000000"/>
                </a:solidFill>
                <a:latin typeface="Calibri"/>
              </a:rPr>
              <a:t> </a:t>
            </a:r>
            <a:r>
              <a:rPr b="0" lang="en-US" sz="6000" spc="-1" strike="noStrike">
                <a:solidFill>
                  <a:srgbClr val="000000"/>
                </a:solidFill>
                <a:latin typeface="Calibri"/>
              </a:rPr>
              <a:t>CHV must keep up with these changes in the language used by consumers. </a:t>
            </a:r>
            <a:endParaRPr b="0" lang="en-US" sz="6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Box 1"/>
          <p:cNvSpPr/>
          <p:nvPr/>
        </p:nvSpPr>
        <p:spPr>
          <a:xfrm>
            <a:off x="2057400" y="2955960"/>
            <a:ext cx="27508320" cy="7470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3133800"/>
                <a:tab algn="l" pos="6267600"/>
                <a:tab algn="l" pos="9401040"/>
              </a:tabLst>
            </a:pPr>
            <a:r>
              <a:rPr b="1" lang="en-US" sz="10000" spc="-1" strike="noStrike">
                <a:solidFill>
                  <a:srgbClr val="000000"/>
                </a:solidFill>
                <a:latin typeface="Calibri"/>
              </a:rPr>
              <a:t>Main Question</a:t>
            </a:r>
            <a:endParaRPr b="0" lang="en-US" sz="10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3133800"/>
                <a:tab algn="l" pos="6267600"/>
                <a:tab algn="l" pos="9401040"/>
              </a:tabLst>
            </a:pP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3133800"/>
                <a:tab algn="l" pos="6267600"/>
                <a:tab algn="l" pos="9401040"/>
              </a:tabLst>
            </a:pP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3133800"/>
                <a:tab algn="l" pos="6267600"/>
                <a:tab algn="l" pos="9401040"/>
              </a:tabLst>
            </a:pPr>
            <a:r>
              <a:rPr b="1" lang="en-US" sz="9600" spc="-1" strike="noStrike">
                <a:solidFill>
                  <a:srgbClr val="000000"/>
                </a:solidFill>
                <a:latin typeface="Calibri"/>
              </a:rPr>
              <a:t>How can a consumer health vocabulary evolve with consumer language?</a:t>
            </a:r>
            <a:endParaRPr b="0" lang="en-US" sz="9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" name="Group 1"/>
          <p:cNvGrpSpPr/>
          <p:nvPr/>
        </p:nvGrpSpPr>
        <p:grpSpPr>
          <a:xfrm>
            <a:off x="2927520" y="636480"/>
            <a:ext cx="27446040" cy="20004120"/>
            <a:chOff x="2927520" y="636480"/>
            <a:chExt cx="27446040" cy="20004120"/>
          </a:xfrm>
        </p:grpSpPr>
        <p:grpSp>
          <p:nvGrpSpPr>
            <p:cNvPr id="48" name="Group 2"/>
            <p:cNvGrpSpPr/>
            <p:nvPr/>
          </p:nvGrpSpPr>
          <p:grpSpPr>
            <a:xfrm>
              <a:off x="2927520" y="1540440"/>
              <a:ext cx="27430920" cy="19100160"/>
              <a:chOff x="2927520" y="1540440"/>
              <a:chExt cx="27430920" cy="19100160"/>
            </a:xfrm>
          </p:grpSpPr>
          <p:sp>
            <p:nvSpPr>
              <p:cNvPr id="49" name="Rectangle 101"/>
              <p:cNvSpPr/>
              <p:nvPr/>
            </p:nvSpPr>
            <p:spPr>
              <a:xfrm>
                <a:off x="2927520" y="1540440"/>
                <a:ext cx="27430920" cy="1910016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eeece1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60000" rIns="360000" tIns="360000" bIns="360000" anchor="t">
                <a:noAutofit/>
              </a:bodyPr>
              <a:p>
                <a:pPr>
                  <a:spcBef>
                    <a:spcPts val="2500"/>
                  </a:spcBef>
                  <a:spcAft>
                    <a:spcPts val="1250"/>
                  </a:spcAft>
                  <a:tabLst>
                    <a:tab algn="l" pos="0"/>
                    <a:tab algn="l" pos="3133800"/>
                    <a:tab algn="l" pos="6267600"/>
                    <a:tab algn="l" pos="9401040"/>
                  </a:tabLst>
                </a:pPr>
                <a:endParaRPr b="0" lang="en-US" sz="6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50" name="Picture 1" descr=""/>
              <p:cNvPicPr/>
              <p:nvPr/>
            </p:nvPicPr>
            <p:blipFill>
              <a:blip r:embed="rId1"/>
              <a:stretch/>
            </p:blipFill>
            <p:spPr>
              <a:xfrm>
                <a:off x="3265200" y="1965960"/>
                <a:ext cx="26907840" cy="1824912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51" name="Rectangle 529"/>
            <p:cNvSpPr/>
            <p:nvPr/>
          </p:nvSpPr>
          <p:spPr>
            <a:xfrm>
              <a:off x="2942640" y="636480"/>
              <a:ext cx="27430920" cy="859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1440" bIns="91440" anchor="t">
              <a:noAutofit/>
            </a:bodyPr>
            <a:p>
              <a:pPr algn="ctr">
                <a:tabLst>
                  <a:tab algn="l" pos="0"/>
                  <a:tab algn="l" pos="3133800"/>
                  <a:tab algn="l" pos="6267600"/>
                  <a:tab algn="l" pos="9401040"/>
                </a:tabLst>
              </a:pPr>
              <a:r>
                <a:rPr b="1" i="1" lang="en-US" sz="4800" spc="-1" strike="noStrike">
                  <a:solidFill>
                    <a:srgbClr val="953735"/>
                  </a:solidFill>
                  <a:latin typeface="Calibri"/>
                </a:rPr>
                <a:t>Schematic Diagram of  the AVM system</a:t>
              </a:r>
              <a:endParaRPr b="0" lang="en-US" sz="4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2" name="Group 13"/>
          <p:cNvGrpSpPr/>
          <p:nvPr/>
        </p:nvGrpSpPr>
        <p:grpSpPr>
          <a:xfrm>
            <a:off x="982800" y="1143000"/>
            <a:ext cx="4471920" cy="6580800"/>
            <a:chOff x="982800" y="1143000"/>
            <a:chExt cx="4471920" cy="6580800"/>
          </a:xfrm>
        </p:grpSpPr>
        <p:sp>
          <p:nvSpPr>
            <p:cNvPr id="53" name="Snip Single Corner Rectangle 3"/>
            <p:cNvSpPr/>
            <p:nvPr/>
          </p:nvSpPr>
          <p:spPr>
            <a:xfrm>
              <a:off x="982800" y="1143000"/>
              <a:ext cx="4471920" cy="5230440"/>
            </a:xfrm>
            <a:custGeom>
              <a:avLst/>
              <a:gdLst/>
              <a:ahLst/>
              <a:rect l="l" t="t" r="r" b="b"/>
              <a:pathLst>
                <a:path w="2801473" h="3779518">
                  <a:moveTo>
                    <a:pt x="0" y="0"/>
                  </a:moveTo>
                  <a:lnTo>
                    <a:pt x="2334551" y="0"/>
                  </a:lnTo>
                  <a:lnTo>
                    <a:pt x="2801473" y="466922"/>
                  </a:lnTo>
                  <a:lnTo>
                    <a:pt x="2801473" y="3779518"/>
                  </a:lnTo>
                  <a:lnTo>
                    <a:pt x="0" y="3779518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25560">
              <a:solidFill>
                <a:srgbClr val="385d8a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6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54" name="Group 11"/>
            <p:cNvGrpSpPr/>
            <p:nvPr/>
          </p:nvGrpSpPr>
          <p:grpSpPr>
            <a:xfrm>
              <a:off x="1000800" y="1221120"/>
              <a:ext cx="4448880" cy="6502680"/>
              <a:chOff x="1000800" y="1221120"/>
              <a:chExt cx="4448880" cy="6502680"/>
            </a:xfrm>
          </p:grpSpPr>
          <p:sp>
            <p:nvSpPr>
              <p:cNvPr id="55" name="TextBox 4"/>
              <p:cNvSpPr/>
              <p:nvPr/>
            </p:nvSpPr>
            <p:spPr>
              <a:xfrm>
                <a:off x="1038240" y="6410880"/>
                <a:ext cx="4411440" cy="1312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3133800"/>
                    <a:tab algn="l" pos="6267600"/>
                    <a:tab algn="l" pos="9401040"/>
                  </a:tabLst>
                </a:pPr>
                <a:r>
                  <a:rPr b="0" lang="en-US" sz="4000" spc="-1" strike="noStrike">
                    <a:solidFill>
                      <a:srgbClr val="000000"/>
                    </a:solidFill>
                    <a:latin typeface="Calibri"/>
                  </a:rPr>
                  <a:t>PatientsLikeMe.com</a:t>
                </a:r>
                <a:endParaRPr b="0" lang="en-US" sz="40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3133800"/>
                    <a:tab algn="l" pos="6267600"/>
                    <a:tab algn="l" pos="9401040"/>
                  </a:tabLst>
                </a:pPr>
                <a:r>
                  <a:rPr b="0" lang="en-US" sz="4000" spc="-1" strike="noStrike">
                    <a:solidFill>
                      <a:srgbClr val="000000"/>
                    </a:solidFill>
                    <a:latin typeface="Calibri"/>
                  </a:rPr>
                  <a:t>Raw text file excerpt</a:t>
                </a:r>
                <a:endParaRPr b="0" lang="en-US" sz="4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" name="TextBox 5"/>
              <p:cNvSpPr/>
              <p:nvPr/>
            </p:nvSpPr>
            <p:spPr>
              <a:xfrm>
                <a:off x="1000800" y="1221120"/>
                <a:ext cx="3630960" cy="4717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3133800"/>
                    <a:tab algn="l" pos="6267600"/>
                    <a:tab algn="l" pos="940104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PatientsLikeMe : Patients Helping 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3133800"/>
                    <a:tab algn="l" pos="6267600"/>
                    <a:tab algn="l" pos="940104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Patients Live Better Every Day. 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3133800"/>
                    <a:tab algn="l" pos="6267600"/>
                    <a:tab algn="l" pos="940104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Secure login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3133800"/>
                    <a:tab algn="l" pos="6267600"/>
                    <a:tab algn="l" pos="940104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Join today!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3133800"/>
                    <a:tab algn="l" pos="6267600"/>
                    <a:tab algn="l" pos="940104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You appear to have JavaScript disabled in 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3133800"/>
                    <a:tab algn="l" pos="6267600"/>
                    <a:tab algn="l" pos="940104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your browser.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3133800"/>
                    <a:tab algn="l" pos="6267600"/>
                    <a:tab algn="l" pos="940104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PatientsLikeMe relies on JavaScript and 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3133800"/>
                    <a:tab algn="l" pos="6267600"/>
                    <a:tab algn="l" pos="940104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Cookies to deliver the best possible 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3133800"/>
                    <a:tab algn="l" pos="6267600"/>
                    <a:tab algn="l" pos="940104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experience to you.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3133800"/>
                    <a:tab algn="l" pos="6267600"/>
                    <a:tab algn="l" pos="940104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How do I enable JavaScript?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3133800"/>
                    <a:tab algn="l" pos="6267600"/>
                    <a:tab algn="l" pos="940104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Find Patients Just Like You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3133800"/>
                    <a:tab algn="l" pos="6267600"/>
                    <a:tab algn="l" pos="940104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I wish this site was around years ago as I 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3133800"/>
                    <a:tab algn="l" pos="6267600"/>
                    <a:tab algn="l" pos="940104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lost so much time and money doing what 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3133800"/>
                    <a:tab algn="l" pos="6267600"/>
                    <a:tab algn="l" pos="940104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didn't work.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3133800"/>
                    <a:tab algn="l" pos="6267600"/>
                    <a:tab algn="l" pos="940104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Multiple Sclerosis Community Member ;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3133800"/>
                    <a:tab algn="l" pos="6267600"/>
                    <a:tab algn="l" pos="940104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Find a patient like you now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3133800"/>
                    <a:tab algn="l" pos="6267600"/>
                    <a:tab algn="l" pos="940104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Current Disease Communities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3133800"/>
                    <a:tab algn="l" pos="6267600"/>
                    <a:tab algn="l" pos="940104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Prevalent Diseases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tabLst>
                    <a:tab algn="l" pos="0"/>
                    <a:tab algn="l" pos="3133800"/>
                    <a:tab algn="l" pos="6267600"/>
                    <a:tab algn="l" pos="940104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</a:rPr>
                  <a:t>ALS/MND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57" name="Group 24"/>
          <p:cNvGrpSpPr/>
          <p:nvPr/>
        </p:nvGrpSpPr>
        <p:grpSpPr>
          <a:xfrm>
            <a:off x="12501720" y="1841400"/>
            <a:ext cx="14384160" cy="6158520"/>
            <a:chOff x="12501720" y="1841400"/>
            <a:chExt cx="14384160" cy="6158520"/>
          </a:xfrm>
        </p:grpSpPr>
        <p:pic>
          <p:nvPicPr>
            <p:cNvPr id="58" name="Object 10" descr=""/>
            <p:cNvPicPr/>
            <p:nvPr/>
          </p:nvPicPr>
          <p:blipFill>
            <a:blip r:embed="rId1"/>
            <a:stretch/>
          </p:blipFill>
          <p:spPr>
            <a:xfrm>
              <a:off x="12501720" y="1841400"/>
              <a:ext cx="14384160" cy="52984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59" name="TextBox 21"/>
            <p:cNvSpPr/>
            <p:nvPr/>
          </p:nvSpPr>
          <p:spPr>
            <a:xfrm>
              <a:off x="16986600" y="7296480"/>
              <a:ext cx="6453360" cy="703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3133800"/>
                  <a:tab algn="l" pos="6267600"/>
                  <a:tab algn="l" pos="9401040"/>
                </a:tabLst>
              </a:pPr>
              <a:r>
                <a:rPr b="0" lang="en-US" sz="4000" spc="-1" strike="noStrike">
                  <a:solidFill>
                    <a:srgbClr val="000000"/>
                  </a:solidFill>
                  <a:latin typeface="Calibri"/>
                </a:rPr>
                <a:t>Excerpt from n-gram database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0" name="Group 25"/>
          <p:cNvGrpSpPr/>
          <p:nvPr/>
        </p:nvGrpSpPr>
        <p:grpSpPr>
          <a:xfrm>
            <a:off x="2776680" y="12877920"/>
            <a:ext cx="11628360" cy="7115400"/>
            <a:chOff x="2776680" y="12877920"/>
            <a:chExt cx="11628360" cy="7115400"/>
          </a:xfrm>
        </p:grpSpPr>
        <p:pic>
          <p:nvPicPr>
            <p:cNvPr id="61" name="Object 15" descr=""/>
            <p:cNvPicPr/>
            <p:nvPr/>
          </p:nvPicPr>
          <p:blipFill>
            <a:blip r:embed="rId2"/>
            <a:stretch/>
          </p:blipFill>
          <p:spPr>
            <a:xfrm>
              <a:off x="2776680" y="12877920"/>
              <a:ext cx="11628360" cy="62611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62" name="TextBox 23"/>
            <p:cNvSpPr/>
            <p:nvPr/>
          </p:nvSpPr>
          <p:spPr>
            <a:xfrm>
              <a:off x="4388760" y="19289880"/>
              <a:ext cx="7954560" cy="703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3133800"/>
                  <a:tab algn="l" pos="6267600"/>
                  <a:tab algn="l" pos="9401040"/>
                </a:tabLst>
              </a:pPr>
              <a:r>
                <a:rPr b="0" lang="en-US" sz="4000" spc="-1" strike="noStrike">
                  <a:solidFill>
                    <a:srgbClr val="000000"/>
                  </a:solidFill>
                  <a:latin typeface="Calibri"/>
                </a:rPr>
                <a:t>Excerpt from potential term database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3" name="Group 27"/>
          <p:cNvGrpSpPr/>
          <p:nvPr/>
        </p:nvGrpSpPr>
        <p:grpSpPr>
          <a:xfrm>
            <a:off x="19547280" y="11931480"/>
            <a:ext cx="11850120" cy="8101800"/>
            <a:chOff x="19547280" y="11931480"/>
            <a:chExt cx="11850120" cy="8101800"/>
          </a:xfrm>
        </p:grpSpPr>
        <p:pic>
          <p:nvPicPr>
            <p:cNvPr id="64" name="Picture 2" descr=""/>
            <p:cNvPicPr/>
            <p:nvPr/>
          </p:nvPicPr>
          <p:blipFill>
            <a:blip r:embed="rId3"/>
            <a:srcRect l="51906" t="3546" r="9168" b="15430"/>
            <a:stretch/>
          </p:blipFill>
          <p:spPr>
            <a:xfrm>
              <a:off x="21487680" y="11931480"/>
              <a:ext cx="9730080" cy="6760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5" name="TextBox 26"/>
            <p:cNvSpPr/>
            <p:nvPr/>
          </p:nvSpPr>
          <p:spPr>
            <a:xfrm>
              <a:off x="19547280" y="18720360"/>
              <a:ext cx="11850120" cy="1312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3133800"/>
                  <a:tab algn="l" pos="6267600"/>
                  <a:tab algn="l" pos="9401040"/>
                </a:tabLst>
              </a:pPr>
              <a:r>
                <a:rPr b="0" lang="en-US" sz="4000" spc="-1" strike="noStrike">
                  <a:solidFill>
                    <a:srgbClr val="000000"/>
                  </a:solidFill>
                  <a:latin typeface="Calibri"/>
                </a:rPr>
                <a:t>CHV Update Wiki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3133800"/>
                  <a:tab algn="l" pos="6267600"/>
                  <a:tab algn="l" pos="9401040"/>
                </a:tabLst>
              </a:pPr>
              <a:r>
                <a:rPr b="0" lang="en-US" sz="4000" spc="-1" strike="noStrike">
                  <a:solidFill>
                    <a:srgbClr val="000000"/>
                  </a:solidFill>
                  <a:latin typeface="Calibri"/>
                </a:rPr>
                <a:t>www.ConsumerHealthVocab.utah.edu/AutoVocabMaint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6" name="Group 7"/>
          <p:cNvGrpSpPr/>
          <p:nvPr/>
        </p:nvGrpSpPr>
        <p:grpSpPr>
          <a:xfrm>
            <a:off x="14706720" y="14052600"/>
            <a:ext cx="6324480" cy="3308400"/>
            <a:chOff x="14706720" y="14052600"/>
            <a:chExt cx="6324480" cy="3308400"/>
          </a:xfrm>
        </p:grpSpPr>
        <p:sp>
          <p:nvSpPr>
            <p:cNvPr id="67" name="TextBox 20"/>
            <p:cNvSpPr/>
            <p:nvPr/>
          </p:nvSpPr>
          <p:spPr>
            <a:xfrm>
              <a:off x="15179040" y="16437960"/>
              <a:ext cx="2947320" cy="923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13560" rIns="313560" tIns="156600" bIns="156600" anchor="t">
              <a:spAutoFit/>
            </a:bodyPr>
            <a:p>
              <a:pPr>
                <a:tabLst>
                  <a:tab algn="l" pos="0"/>
                  <a:tab algn="l" pos="3133800"/>
                  <a:tab algn="l" pos="6267600"/>
                  <a:tab algn="l" pos="9401040"/>
                </a:tabLst>
              </a:pPr>
              <a:r>
                <a:rPr b="0" lang="en-US" sz="4000" spc="-1" strike="noStrike">
                  <a:solidFill>
                    <a:srgbClr val="c00000"/>
                  </a:solidFill>
                  <a:latin typeface="Calibri"/>
                </a:rPr>
                <a:t>Stage 2  (C)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Right Arrow 17"/>
            <p:cNvSpPr/>
            <p:nvPr/>
          </p:nvSpPr>
          <p:spPr>
            <a:xfrm>
              <a:off x="14706720" y="14052600"/>
              <a:ext cx="6324480" cy="2903760"/>
            </a:xfrm>
            <a:prstGeom prst="rightArrow">
              <a:avLst>
                <a:gd name="adj1" fmla="val 50000"/>
                <a:gd name="adj2" fmla="val 59482"/>
              </a:avLst>
            </a:prstGeom>
            <a:solidFill>
              <a:srgbClr val="c00000">
                <a:alpha val="32000"/>
              </a:srgbClr>
            </a:solidFill>
            <a:ln w="25560">
              <a:solidFill>
                <a:srgbClr val="c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3133800"/>
                  <a:tab algn="l" pos="6267600"/>
                  <a:tab algn="l" pos="9401040"/>
                </a:tabLst>
              </a:pPr>
              <a:endParaRPr b="0" lang="en-US" sz="6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9" name="Group 6"/>
          <p:cNvGrpSpPr/>
          <p:nvPr/>
        </p:nvGrpSpPr>
        <p:grpSpPr>
          <a:xfrm>
            <a:off x="7303320" y="6736320"/>
            <a:ext cx="8304840" cy="6185160"/>
            <a:chOff x="7303320" y="6736320"/>
            <a:chExt cx="8304840" cy="6185160"/>
          </a:xfrm>
        </p:grpSpPr>
        <p:sp>
          <p:nvSpPr>
            <p:cNvPr id="70" name="TextBox 16"/>
            <p:cNvSpPr/>
            <p:nvPr/>
          </p:nvSpPr>
          <p:spPr>
            <a:xfrm rot="19806600">
              <a:off x="11056680" y="10460880"/>
              <a:ext cx="3706200" cy="923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13560" rIns="313560" tIns="156600" bIns="156600" anchor="t">
              <a:spAutoFit/>
            </a:bodyPr>
            <a:p>
              <a:pPr>
                <a:tabLst>
                  <a:tab algn="l" pos="0"/>
                  <a:tab algn="l" pos="3133800"/>
                  <a:tab algn="l" pos="6267600"/>
                  <a:tab algn="l" pos="9401040"/>
                </a:tabLst>
              </a:pPr>
              <a:r>
                <a:rPr b="0" lang="en-US" sz="4000" spc="-1" strike="noStrike">
                  <a:solidFill>
                    <a:srgbClr val="c00000"/>
                  </a:solidFill>
                  <a:latin typeface="Calibri"/>
                </a:rPr>
                <a:t>Stage 2 (A &amp; B)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Right Arrow 14"/>
            <p:cNvSpPr/>
            <p:nvPr/>
          </p:nvSpPr>
          <p:spPr>
            <a:xfrm rot="9002400">
              <a:off x="7359120" y="8620560"/>
              <a:ext cx="8192880" cy="2416680"/>
            </a:xfrm>
            <a:prstGeom prst="rightArrow">
              <a:avLst>
                <a:gd name="adj1" fmla="val 50000"/>
                <a:gd name="adj2" fmla="val 148428"/>
              </a:avLst>
            </a:prstGeom>
            <a:solidFill>
              <a:srgbClr val="c00000">
                <a:alpha val="34000"/>
              </a:srgbClr>
            </a:solidFill>
            <a:ln w="25560">
              <a:solidFill>
                <a:srgbClr val="c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3133800"/>
                  <a:tab algn="l" pos="6267600"/>
                  <a:tab algn="l" pos="9401040"/>
                </a:tabLst>
              </a:pPr>
              <a:endParaRPr b="0" lang="en-US" sz="6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2" name="Group 2"/>
          <p:cNvGrpSpPr/>
          <p:nvPr/>
        </p:nvGrpSpPr>
        <p:grpSpPr>
          <a:xfrm>
            <a:off x="5908680" y="2603520"/>
            <a:ext cx="6130800" cy="2703600"/>
            <a:chOff x="5908680" y="2603520"/>
            <a:chExt cx="6130800" cy="2703600"/>
          </a:xfrm>
        </p:grpSpPr>
        <p:sp>
          <p:nvSpPr>
            <p:cNvPr id="73" name="TextBox 9"/>
            <p:cNvSpPr/>
            <p:nvPr/>
          </p:nvSpPr>
          <p:spPr>
            <a:xfrm>
              <a:off x="6513480" y="4384080"/>
              <a:ext cx="4154760" cy="923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313560" rIns="313560" tIns="156600" bIns="156600" anchor="t">
              <a:spAutoFit/>
            </a:bodyPr>
            <a:p>
              <a:pPr>
                <a:tabLst>
                  <a:tab algn="l" pos="0"/>
                  <a:tab algn="l" pos="3133800"/>
                  <a:tab algn="l" pos="6267600"/>
                  <a:tab algn="l" pos="9401040"/>
                </a:tabLst>
              </a:pPr>
              <a:r>
                <a:rPr b="0" lang="en-US" sz="4000" spc="-1" strike="noStrike">
                  <a:solidFill>
                    <a:srgbClr val="c00000"/>
                  </a:solidFill>
                  <a:latin typeface="Calibri"/>
                </a:rPr>
                <a:t>Stage 1 (A,B &amp; C)</a:t>
              </a:r>
              <a:endParaRPr b="0" lang="en-US" sz="4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Right Arrow 8"/>
            <p:cNvSpPr/>
            <p:nvPr/>
          </p:nvSpPr>
          <p:spPr>
            <a:xfrm>
              <a:off x="5908680" y="2603520"/>
              <a:ext cx="6130800" cy="2265840"/>
            </a:xfrm>
            <a:prstGeom prst="rightArrow">
              <a:avLst>
                <a:gd name="adj1" fmla="val 50000"/>
                <a:gd name="adj2" fmla="val 72755"/>
              </a:avLst>
            </a:prstGeom>
            <a:solidFill>
              <a:srgbClr val="c00000">
                <a:alpha val="34000"/>
              </a:srgbClr>
            </a:solidFill>
            <a:ln w="25560">
              <a:solidFill>
                <a:srgbClr val="c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13560" rIns="313560" tIns="156600" bIns="156600" anchor="ctr">
              <a:noAutofit/>
            </a:bodyPr>
            <a:p>
              <a:pPr algn="ctr">
                <a:tabLst>
                  <a:tab algn="l" pos="0"/>
                  <a:tab algn="l" pos="3133800"/>
                  <a:tab algn="l" pos="6267600"/>
                  <a:tab algn="l" pos="9401040"/>
                </a:tabLst>
              </a:pPr>
              <a:endParaRPr b="0" lang="en-US" sz="6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TextBox 2"/>
          <p:cNvSpPr/>
          <p:nvPr/>
        </p:nvSpPr>
        <p:spPr>
          <a:xfrm>
            <a:off x="2971800" y="2743200"/>
            <a:ext cx="24841080" cy="1557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3133800"/>
                <a:tab algn="l" pos="6267600"/>
                <a:tab algn="l" pos="9401040"/>
              </a:tabLst>
            </a:pPr>
            <a:r>
              <a:rPr b="1" lang="en-US" sz="8000" spc="-1" strike="noStrike">
                <a:solidFill>
                  <a:srgbClr val="000000"/>
                </a:solidFill>
                <a:latin typeface="Calibri"/>
              </a:rPr>
              <a:t>Results</a:t>
            </a:r>
            <a:endParaRPr b="0" lang="en-US" sz="8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3133800"/>
                <a:tab algn="l" pos="6267600"/>
                <a:tab algn="l" pos="940104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3133800"/>
                <a:tab algn="l" pos="6267600"/>
                <a:tab algn="l" pos="9401040"/>
              </a:tabLst>
            </a:pPr>
            <a:r>
              <a:rPr b="0" lang="en-US" sz="7200" spc="-1" strike="noStrike">
                <a:solidFill>
                  <a:srgbClr val="000000"/>
                </a:solidFill>
                <a:latin typeface="Calibri"/>
              </a:rPr>
              <a:t>Combined: Termhood score threshold of 3.6 for terms found in the medical records and C-value threshold of 15.</a:t>
            </a: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3133800"/>
                <a:tab algn="l" pos="6267600"/>
                <a:tab algn="l" pos="940104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3133800"/>
                <a:tab algn="l" pos="6267600"/>
                <a:tab algn="l" pos="940104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3133800"/>
                <a:tab algn="l" pos="6267600"/>
                <a:tab algn="l" pos="9401040"/>
              </a:tabLst>
            </a:pPr>
            <a:r>
              <a:rPr b="0" lang="en-US" sz="7200" spc="-1" strike="noStrike">
                <a:solidFill>
                  <a:srgbClr val="000000"/>
                </a:solidFill>
                <a:latin typeface="Calibri"/>
              </a:rPr>
              <a:t>Produced 774 candidate terms, with 237 valid terms. </a:t>
            </a: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3133800"/>
                <a:tab algn="l" pos="6267600"/>
                <a:tab algn="l" pos="940104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3133800"/>
                <a:tab algn="l" pos="6267600"/>
                <a:tab algn="l" pos="940104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3133800"/>
                <a:tab algn="l" pos="6267600"/>
                <a:tab algn="l" pos="9401040"/>
              </a:tabLst>
            </a:pPr>
            <a:r>
              <a:rPr b="0" lang="en-US" sz="7200" spc="-1" strike="noStrike">
                <a:solidFill>
                  <a:srgbClr val="000000"/>
                </a:solidFill>
                <a:latin typeface="Calibri"/>
              </a:rPr>
              <a:t>Reviewers will find 1 valid term for every 3 or 4 candidate terms. </a:t>
            </a: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3133800"/>
                <a:tab algn="l" pos="6267600"/>
                <a:tab algn="l" pos="940104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3133800"/>
                <a:tab algn="l" pos="6267600"/>
                <a:tab algn="l" pos="940104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3133800"/>
                <a:tab algn="l" pos="6267600"/>
                <a:tab algn="l" pos="9401040"/>
              </a:tabLst>
            </a:pPr>
            <a:r>
              <a:rPr b="0" lang="en-US" sz="7200" spc="-1" strike="noStrike">
                <a:solidFill>
                  <a:srgbClr val="000000"/>
                </a:solidFill>
                <a:latin typeface="Calibri"/>
              </a:rPr>
              <a:t>Better than initial n-gram list with an average of 1 valid term for every 137 candidate terms.</a:t>
            </a: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Rectangle 529"/>
          <p:cNvSpPr/>
          <p:nvPr/>
        </p:nvSpPr>
        <p:spPr>
          <a:xfrm>
            <a:off x="1676520" y="2666880"/>
            <a:ext cx="26974800" cy="1668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60000" rIns="360000" tIns="360000" bIns="360000" anchor="t">
            <a:noAutofit/>
          </a:bodyPr>
          <a:p>
            <a:pPr algn="ctr">
              <a:tabLst>
                <a:tab algn="l" pos="0"/>
                <a:tab algn="l" pos="3133800"/>
                <a:tab algn="l" pos="6267600"/>
                <a:tab algn="l" pos="9401040"/>
              </a:tabLst>
            </a:pPr>
            <a:r>
              <a:rPr b="1" lang="en-US" sz="8000" spc="-1" strike="noStrike">
                <a:solidFill>
                  <a:srgbClr val="953735"/>
                </a:solidFill>
                <a:latin typeface="Calibri"/>
              </a:rPr>
              <a:t>Summary of Conclusions</a:t>
            </a:r>
            <a:endParaRPr b="0" lang="en-US" sz="8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3133800"/>
                <a:tab algn="l" pos="6267600"/>
                <a:tab algn="l" pos="940104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953735"/>
              </a:buClr>
              <a:buFont typeface="Arial"/>
              <a:buChar char="•"/>
              <a:tabLst>
                <a:tab algn="l" pos="3133800"/>
                <a:tab algn="l" pos="6267600"/>
                <a:tab algn="l" pos="9401040"/>
              </a:tabLst>
            </a:pPr>
            <a:r>
              <a:rPr b="0" lang="en-US" sz="7200" spc="-1" strike="noStrike">
                <a:solidFill>
                  <a:srgbClr val="953735"/>
                </a:solidFill>
                <a:latin typeface="Calibri"/>
              </a:rPr>
              <a:t>Social network data can be used to provide a living corpus.</a:t>
            </a: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953735"/>
              </a:buClr>
              <a:buFont typeface="Arial"/>
              <a:buChar char="•"/>
              <a:tabLst>
                <a:tab algn="l" pos="3133800"/>
                <a:tab algn="l" pos="6267600"/>
                <a:tab algn="l" pos="940104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953735"/>
              </a:buClr>
              <a:buFont typeface="Arial"/>
              <a:buChar char="•"/>
              <a:tabLst>
                <a:tab algn="l" pos="3133800"/>
                <a:tab algn="l" pos="6267600"/>
                <a:tab algn="l" pos="940104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953735"/>
              </a:buClr>
              <a:buFont typeface="Arial"/>
              <a:buChar char="•"/>
              <a:tabLst>
                <a:tab algn="l" pos="3133800"/>
                <a:tab algn="l" pos="6267600"/>
                <a:tab algn="l" pos="9401040"/>
              </a:tabLst>
            </a:pPr>
            <a:r>
              <a:rPr b="0" lang="en-US" sz="7200" spc="-1" strike="noStrike">
                <a:solidFill>
                  <a:srgbClr val="953735"/>
                </a:solidFill>
                <a:latin typeface="Calibri"/>
              </a:rPr>
              <a:t>It can be mined to provide new consumer health vocabulary terms. </a:t>
            </a: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953735"/>
              </a:buClr>
              <a:buFont typeface="Arial"/>
              <a:buChar char="•"/>
              <a:tabLst>
                <a:tab algn="l" pos="3133800"/>
                <a:tab algn="l" pos="6267600"/>
                <a:tab algn="l" pos="940104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953735"/>
              </a:buClr>
              <a:buFont typeface="Arial"/>
              <a:buChar char="•"/>
              <a:tabLst>
                <a:tab algn="l" pos="3133800"/>
                <a:tab algn="l" pos="6267600"/>
                <a:tab algn="l" pos="940104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953735"/>
              </a:buClr>
              <a:buFont typeface="Arial"/>
              <a:buChar char="•"/>
              <a:tabLst>
                <a:tab algn="l" pos="3133800"/>
                <a:tab algn="l" pos="6267600"/>
                <a:tab algn="l" pos="9401040"/>
              </a:tabLst>
            </a:pPr>
            <a:r>
              <a:rPr b="0" lang="en-US" sz="7200" spc="-1" strike="noStrike">
                <a:solidFill>
                  <a:srgbClr val="953735"/>
                </a:solidFill>
                <a:latin typeface="Calibri"/>
              </a:rPr>
              <a:t>Using ATR and dictionary look up can produce a concise list of candidate terms.</a:t>
            </a: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953735"/>
              </a:buClr>
              <a:buFont typeface="Arial"/>
              <a:buChar char="•"/>
              <a:tabLst>
                <a:tab algn="l" pos="3133800"/>
                <a:tab algn="l" pos="6267600"/>
                <a:tab algn="l" pos="940104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953735"/>
              </a:buClr>
              <a:buFont typeface="Arial"/>
              <a:buChar char="•"/>
              <a:tabLst>
                <a:tab algn="l" pos="3133800"/>
                <a:tab algn="l" pos="6267600"/>
                <a:tab algn="l" pos="9401040"/>
              </a:tabLst>
            </a:pP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  <a:p>
            <a:pPr>
              <a:buClr>
                <a:srgbClr val="953735"/>
              </a:buClr>
              <a:buFont typeface="Arial"/>
              <a:buChar char="•"/>
              <a:tabLst>
                <a:tab algn="l" pos="3133800"/>
                <a:tab algn="l" pos="6267600"/>
                <a:tab algn="l" pos="9401040"/>
              </a:tabLst>
            </a:pPr>
            <a:r>
              <a:rPr b="0" lang="en-US" sz="7200" spc="-1" strike="noStrike">
                <a:solidFill>
                  <a:srgbClr val="953735"/>
                </a:solidFill>
                <a:latin typeface="Calibri"/>
              </a:rPr>
              <a:t>Allowing the consumer health vocabulary to evolve with consumer language.</a:t>
            </a:r>
            <a:endParaRPr b="0" lang="en-US" sz="7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7" name="Group 1"/>
          <p:cNvGrpSpPr/>
          <p:nvPr/>
        </p:nvGrpSpPr>
        <p:grpSpPr>
          <a:xfrm>
            <a:off x="7777080" y="5521680"/>
            <a:ext cx="14925600" cy="13296600"/>
            <a:chOff x="7777080" y="5521680"/>
            <a:chExt cx="14925600" cy="13296600"/>
          </a:xfrm>
        </p:grpSpPr>
        <p:pic>
          <p:nvPicPr>
            <p:cNvPr id="78" name="Picture 45" descr="ThreeColorLogo"/>
            <p:cNvPicPr/>
            <p:nvPr/>
          </p:nvPicPr>
          <p:blipFill>
            <a:blip r:embed="rId1"/>
            <a:stretch/>
          </p:blipFill>
          <p:spPr>
            <a:xfrm>
              <a:off x="7777080" y="15761160"/>
              <a:ext cx="12868200" cy="3057120"/>
            </a:xfrm>
            <a:prstGeom prst="rect">
              <a:avLst/>
            </a:prstGeom>
            <a:ln w="9360">
              <a:solidFill>
                <a:srgbClr val="eeece1"/>
              </a:solidFill>
              <a:miter/>
            </a:ln>
          </p:spPr>
        </p:pic>
        <p:sp>
          <p:nvSpPr>
            <p:cNvPr id="79" name="Rectangle 18"/>
            <p:cNvSpPr/>
            <p:nvPr/>
          </p:nvSpPr>
          <p:spPr>
            <a:xfrm>
              <a:off x="7777080" y="11255040"/>
              <a:ext cx="14925600" cy="2514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spAutoFit/>
            </a:bodyPr>
            <a:p>
              <a:pPr>
                <a:spcAft>
                  <a:spcPts val="601"/>
                </a:spcAft>
                <a:tabLst>
                  <a:tab algn="l" pos="0"/>
                  <a:tab algn="l" pos="3133800"/>
                  <a:tab algn="l" pos="6267600"/>
                  <a:tab algn="l" pos="9401040"/>
                </a:tabLst>
              </a:pPr>
              <a:r>
                <a:rPr b="1" lang="en-GB" sz="8000" spc="-1" strike="noStrike">
                  <a:solidFill>
                    <a:srgbClr val="b03333"/>
                  </a:solidFill>
                  <a:latin typeface="Calibri"/>
                  <a:ea typeface="Arial"/>
                </a:rPr>
                <a:t>Contact Information</a:t>
              </a:r>
              <a:endParaRPr b="0" lang="en-US" sz="8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spcAft>
                  <a:spcPts val="601"/>
                </a:spcAft>
                <a:tabLst>
                  <a:tab algn="l" pos="0"/>
                  <a:tab algn="l" pos="3133800"/>
                  <a:tab algn="l" pos="6267600"/>
                  <a:tab algn="l" pos="9401040"/>
                </a:tabLst>
              </a:pPr>
              <a:r>
                <a:rPr b="0" lang="en-US" sz="8000" spc="-1" strike="noStrike" u="sng">
                  <a:solidFill>
                    <a:srgbClr val="000000"/>
                  </a:solidFill>
                  <a:uFillTx/>
                  <a:latin typeface="Calibri"/>
                </a:rPr>
                <a:t>Kristia.Doing-Harris@utah.edu</a:t>
              </a:r>
              <a:endParaRPr b="0" lang="en-US" sz="8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TextBox 5"/>
            <p:cNvSpPr/>
            <p:nvPr/>
          </p:nvSpPr>
          <p:spPr>
            <a:xfrm>
              <a:off x="7777080" y="5521680"/>
              <a:ext cx="14925600" cy="3827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spAutoFit/>
            </a:bodyPr>
            <a:p>
              <a:pPr>
                <a:spcAft>
                  <a:spcPts val="601"/>
                </a:spcAft>
                <a:tabLst>
                  <a:tab algn="l" pos="0"/>
                  <a:tab algn="l" pos="3133800"/>
                  <a:tab algn="l" pos="6267600"/>
                  <a:tab algn="l" pos="9401040"/>
                </a:tabLst>
              </a:pPr>
              <a:r>
                <a:rPr b="1" lang="en-GB" sz="8000" spc="-1" strike="noStrike">
                  <a:solidFill>
                    <a:srgbClr val="b03333"/>
                  </a:solidFill>
                  <a:latin typeface="Calibri"/>
                  <a:ea typeface="Arial"/>
                </a:rPr>
                <a:t>Acknowledgements</a:t>
              </a:r>
              <a:endParaRPr b="0" lang="en-US" sz="8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3133800"/>
                  <a:tab algn="l" pos="6267600"/>
                  <a:tab algn="l" pos="9401040"/>
                </a:tabLst>
              </a:pPr>
              <a:r>
                <a:rPr b="0" lang="en-US" sz="8000" spc="-1" strike="noStrike">
                  <a:solidFill>
                    <a:srgbClr val="000000"/>
                  </a:solidFill>
                  <a:latin typeface="Calibri"/>
                </a:rPr>
                <a:t>NLM Training Grant No. RO1 LM07222</a:t>
              </a:r>
              <a:endParaRPr b="0" lang="en-US" sz="8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81" name="TextBox 6"/>
          <p:cNvSpPr/>
          <p:nvPr/>
        </p:nvSpPr>
        <p:spPr>
          <a:xfrm>
            <a:off x="7777080" y="1851120"/>
            <a:ext cx="14925600" cy="2608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spAutoFit/>
          </a:bodyPr>
          <a:p>
            <a:pPr>
              <a:spcAft>
                <a:spcPts val="601"/>
              </a:spcAft>
              <a:tabLst>
                <a:tab algn="l" pos="0"/>
                <a:tab algn="l" pos="3133800"/>
                <a:tab algn="l" pos="6267600"/>
                <a:tab algn="l" pos="9401040"/>
              </a:tabLst>
            </a:pPr>
            <a:r>
              <a:rPr b="1" lang="en-GB" sz="8000" spc="-1" strike="noStrike">
                <a:solidFill>
                  <a:srgbClr val="b03333"/>
                </a:solidFill>
                <a:latin typeface="Calibri"/>
                <a:ea typeface="Arial"/>
              </a:rPr>
              <a:t>CHV Website</a:t>
            </a:r>
            <a:endParaRPr b="0" lang="en-US" sz="8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3133800"/>
                <a:tab algn="l" pos="6267600"/>
                <a:tab algn="l" pos="9401040"/>
              </a:tabLst>
            </a:pPr>
            <a:r>
              <a:rPr b="0" lang="en-US" sz="8000" spc="-1" strike="noStrike">
                <a:solidFill>
                  <a:srgbClr val="000000"/>
                </a:solidFill>
                <a:latin typeface="Calibri"/>
              </a:rPr>
              <a:t>www.ConsumerHealthVocab.org</a:t>
            </a:r>
            <a:endParaRPr b="0" lang="en-US" sz="8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2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11T18:05:12Z</dcterms:created>
  <dc:creator>Kristina Doing-Harris</dc:creator>
  <dc:description/>
  <dc:language>en-US</dc:language>
  <cp:lastModifiedBy>Phil Cairns</cp:lastModifiedBy>
  <dcterms:modified xsi:type="dcterms:W3CDTF">2011-05-11T18:57:36Z</dcterms:modified>
  <cp:revision>23</cp:revision>
  <dc:subject/>
  <dc:title>PowerPoint Presentation</dc:title>
</cp:coreProperties>
</file>